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9F7012-EFF4-48A3-B89D-72E7EC8B77B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2FDD91-AC02-4E24-9322-EC1D3CAE437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F62257-806E-4C82-83E0-908CA460405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170D09-7ADB-4530-9AA2-EDE0EA1F5AF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C86D6B-768C-4B52-956A-19770287B1D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A11625-EF5D-436A-AB3D-80A2DF7A8E7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1D8E75-4D90-4D64-863B-5EF2E8C4DF5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1A71E2-E210-4281-963B-51409F8E219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603AB2-71FD-4FDB-B83D-07D7138DD98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566461-AE16-4F85-BD48-B6E6B1FAA0D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8E0648-260D-4AA2-8651-D042FC15B62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DC337B-0921-42D3-A4CD-CBE551E6779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194AC55-553A-4E1C-A70E-6C2AB9E9FF1B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800" spc="-1" strike="noStrike">
                <a:solidFill>
                  <a:srgbClr val="000000"/>
                </a:solidFill>
                <a:latin typeface="Calibri"/>
              </a:rPr>
              <a:t>Experimental and atmospheric nucleation rates versus H</a:t>
            </a:r>
            <a:r>
              <a:rPr b="0" lang="en-IN" sz="1800" spc="-1" strike="noStrike" baseline="-25000">
                <a:solidFill>
                  <a:srgbClr val="000000"/>
                </a:solidFill>
                <a:latin typeface="Calibri"/>
              </a:rPr>
              <a:t>2</a:t>
            </a:r>
            <a:r>
              <a:rPr b="0" lang="en-IN" sz="1800" spc="-1" strike="noStrike">
                <a:solidFill>
                  <a:srgbClr val="000000"/>
                </a:solidFill>
                <a:latin typeface="Calibri"/>
              </a:rPr>
              <a:t>SO</a:t>
            </a:r>
            <a:r>
              <a:rPr b="0" lang="en-IN" sz="1800" spc="-1" strike="noStrike" baseline="-25000">
                <a:solidFill>
                  <a:srgbClr val="000000"/>
                </a:solidFill>
                <a:latin typeface="Calibri"/>
              </a:rPr>
              <a:t>4</a:t>
            </a:r>
            <a:r>
              <a:rPr b="0" lang="en-IN" sz="1800" spc="-1" strike="noStrike">
                <a:solidFill>
                  <a:srgbClr val="000000"/>
                </a:solidFill>
                <a:latin typeface="Calibri"/>
              </a:rPr>
              <a:t> concentration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Picture 5" descr="D:\PPT_Out\nature-logo.jpg"/>
          <p:cNvPicPr/>
          <p:nvPr/>
        </p:nvPicPr>
        <p:blipFill>
          <a:blip r:embed="rId1"/>
          <a:stretch/>
        </p:blipFill>
        <p:spPr>
          <a:xfrm>
            <a:off x="6985080" y="6222960"/>
            <a:ext cx="1333440" cy="279360"/>
          </a:xfrm>
          <a:prstGeom prst="rect">
            <a:avLst/>
          </a:prstGeom>
          <a:ln w="0">
            <a:noFill/>
          </a:ln>
        </p:spPr>
      </p:pic>
      <p:sp>
        <p:nvSpPr>
          <p:cNvPr id="43" name="Title 1"/>
          <p:cNvSpPr/>
          <p:nvPr/>
        </p:nvSpPr>
        <p:spPr>
          <a:xfrm>
            <a:off x="444600" y="5851440"/>
            <a:ext cx="822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200" spc="-1" strike="noStrike">
                <a:solidFill>
                  <a:srgbClr val="000000"/>
                </a:solidFill>
                <a:latin typeface="Calibri"/>
              </a:rPr>
              <a:t>J Kirkby</a:t>
            </a:r>
            <a:r>
              <a:rPr b="0" i="1" lang="fr-FR" sz="1200" spc="-1" strike="noStrike">
                <a:solidFill>
                  <a:srgbClr val="000000"/>
                </a:solidFill>
                <a:latin typeface="Arial"/>
              </a:rPr>
              <a:t> et al.  Nature </a:t>
            </a:r>
            <a:r>
              <a:rPr b="1" lang="fr-FR" sz="1200" spc="-1" strike="noStrike">
                <a:solidFill>
                  <a:srgbClr val="000000"/>
                </a:solidFill>
                <a:latin typeface="Arial"/>
              </a:rPr>
              <a:t>533,</a:t>
            </a: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 521–526 (2016) doi:10.1038/nature1795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4" name="Picture 6" descr="D:\Shilpa\2016\May\18\nature17953\300 dpi\nature17953-f4.jpg"/>
          <p:cNvPicPr/>
          <p:nvPr/>
        </p:nvPicPr>
        <p:blipFill>
          <a:blip r:embed="rId2"/>
          <a:stretch/>
        </p:blipFill>
        <p:spPr>
          <a:xfrm>
            <a:off x="2362320" y="1600200"/>
            <a:ext cx="4419360" cy="3916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5-04T11:33:05Z</dcterms:created>
  <dc:creator>ravikumar.n</dc:creator>
  <dc:description/>
  <dc:language>en-US</dc:language>
  <cp:lastModifiedBy>Ky.Shilpashree</cp:lastModifiedBy>
  <dcterms:modified xsi:type="dcterms:W3CDTF">2016-05-18T09:52:45Z</dcterms:modified>
  <cp:revision>10</cp:revision>
  <dc:subject/>
  <dc:title>Phylogenetic relationship of salmonids and relevant teleost lineages</dc:title>
</cp:coreProperties>
</file>